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5" d="100"/>
          <a:sy n="95" d="100"/>
        </p:scale>
        <p:origin x="-71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730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2254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3855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50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734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141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3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947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734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723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263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ABDCF1-3E8F-4B51-A84D-4B5A536039DD}" type="datetimeFigureOut">
              <a:rPr kumimoji="1" lang="ja-JP" altLang="en-US" smtClean="0"/>
              <a:t>2017/8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46CC80-5FA3-4E7B-BE27-216D30B2D1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523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9664" y="0"/>
            <a:ext cx="5105845" cy="6492240"/>
          </a:xfrm>
          <a:prstGeom prst="rect">
            <a:avLst/>
          </a:prstGeom>
        </p:spPr>
      </p:pic>
      <p:sp>
        <p:nvSpPr>
          <p:cNvPr id="5" name="正方形/長方形 4"/>
          <p:cNvSpPr/>
          <p:nvPr/>
        </p:nvSpPr>
        <p:spPr>
          <a:xfrm>
            <a:off x="2172271" y="6138297"/>
            <a:ext cx="422852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ja-JP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s for Brunt grade, Brunt stage and fat droplet.</a:t>
            </a:r>
            <a:endParaRPr lang="en-US" altLang="ja-JP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s calculated by ordinal logistic regression was shown for A) Brunt grade, B) Brunt stage and C) fat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roplet</a:t>
            </a:r>
            <a:r>
              <a:rPr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ent</a:t>
            </a:r>
            <a:r>
              <a:rPr lang="en-US" altLang="ja-JP" sz="1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1592627" y="3150542"/>
            <a:ext cx="928459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kumimoji="1" lang="en-US" altLang="ja-JP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)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1592627" y="1094581"/>
            <a:ext cx="928459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kumimoji="1" lang="en-US" altLang="ja-JP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)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1592627" y="5094365"/>
            <a:ext cx="928459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kumimoji="1" lang="en-US" altLang="ja-JP" sz="9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)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5100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0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isa Kawaguchi</dc:creator>
  <cp:lastModifiedBy>tkawa</cp:lastModifiedBy>
  <cp:revision>5</cp:revision>
  <dcterms:created xsi:type="dcterms:W3CDTF">2017-06-17T12:18:29Z</dcterms:created>
  <dcterms:modified xsi:type="dcterms:W3CDTF">2017-08-25T16:53:55Z</dcterms:modified>
</cp:coreProperties>
</file>